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  <p:sldId id="261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94"/>
    <p:restoredTop sz="94694"/>
  </p:normalViewPr>
  <p:slideViewPr>
    <p:cSldViewPr snapToGrid="0" snapToObjects="1">
      <p:cViewPr varScale="1">
        <p:scale>
          <a:sx n="127" d="100"/>
          <a:sy n="127" d="100"/>
        </p:scale>
        <p:origin x="216" y="6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2D72A5-C50C-EF4A-BE9D-370C34B9B3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BB98E6A-ED42-534E-8B09-613F36BFA6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2DDCC4-505A-7F4B-9662-C0051CFE0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1DE19-8D49-8845-9959-29364BB723B0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8FD1ED-D2E9-9B4D-B4BB-7720480763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5CF1AA-A751-A245-83F1-C914F9651A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7D6BF-15B7-4741-8CB5-CB002979C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4200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5CF409-86AF-3D49-A623-24450DA8BF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E1BCE7-BFF5-0B49-A3D7-8A9C038391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649A69-6C9A-4F43-AA15-832108C2E7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1DE19-8D49-8845-9959-29364BB723B0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2F16EE-4B4E-8243-8865-D0E7B8CEC7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A2949E-8F47-CD41-9C30-A633FC40F4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7D6BF-15B7-4741-8CB5-CB002979C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167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FC0DD39-3977-CD43-AC3D-822C172218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83695A-5DC3-E44F-B28C-2595E771C8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ED77E8-97C3-E84A-A83B-CF641ED4B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1DE19-8D49-8845-9959-29364BB723B0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49611B-751B-0941-9F0A-A69311FA9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1883E7-220E-7449-98D4-FECE8A516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7D6BF-15B7-4741-8CB5-CB002979C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748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824581-940E-D04B-9535-FAE80F86A6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1FB156-86E6-FA4C-B3FF-FE2692C26F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D9473E-8D05-D64E-8102-96307AD28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1DE19-8D49-8845-9959-29364BB723B0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654A54-C0FE-8841-965A-FE5B9C716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68BC11-0D15-1B4C-B90B-8515226796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7D6BF-15B7-4741-8CB5-CB002979C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335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6298E5-9DFC-5A41-91BB-EE3A1B7EF9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4E6D7F-BF15-6D41-B2CC-E8ECB39B7C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AEF657-652C-E14E-AB05-52C8B0B56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1DE19-8D49-8845-9959-29364BB723B0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3561CE-0BA8-F345-A3BD-048C917D66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C00167-8EEE-594A-BD76-72829DE88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7D6BF-15B7-4741-8CB5-CB002979C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488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22FF23-98DA-B44D-911D-F01E4EADC5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2CE691-9735-084A-8DF9-911C2FE15C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62ADA2-BE23-714C-B4F1-5FDB16C7F7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8C8466-EE14-464F-B1CD-CC9DAB36B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1DE19-8D49-8845-9959-29364BB723B0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C2B46D-F3D6-A141-9739-BFF9C13C9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DB90EF-2E77-8F49-81B0-18B20168D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7D6BF-15B7-4741-8CB5-CB002979C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829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0638D8-2697-704B-90B9-83A1E6161C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5B7FE9-8996-9E45-816F-838CBA2C51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CFBB18-9C0A-E94F-9EB5-A753D93ABF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07DAF3A-1314-6548-A3AF-1C938C4B3A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F2E9CC9-AFBF-F04F-974E-7691E237F1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9D39876-B5E6-AC4B-8B07-179C6F203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1DE19-8D49-8845-9959-29364BB723B0}" type="datetimeFigureOut">
              <a:rPr lang="en-US" smtClean="0"/>
              <a:t>9/24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62B40A-1262-CA4D-A736-99504C45F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AFA12F-171C-1748-A683-0FA3E998F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7D6BF-15B7-4741-8CB5-CB002979C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661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30079-8B61-BA48-A38E-E88D1C500C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BF1586-8D0B-504D-A69E-F0159CDA2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1DE19-8D49-8845-9959-29364BB723B0}" type="datetimeFigureOut">
              <a:rPr lang="en-US" smtClean="0"/>
              <a:t>9/24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A139B0-8BC2-354B-AE46-E2624BD6E9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7F6D7D3-A15A-684F-AA8F-8B2F0C42E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7D6BF-15B7-4741-8CB5-CB002979C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595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C3E7C17-1577-DF42-A83F-A0352B068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1DE19-8D49-8845-9959-29364BB723B0}" type="datetimeFigureOut">
              <a:rPr lang="en-US" smtClean="0"/>
              <a:t>9/24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96BDA7A-BF54-BD42-9440-FFB825344A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35B75A3-C8F1-DD46-9AEE-4B922ED6C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7D6BF-15B7-4741-8CB5-CB002979C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084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EFEB53-FF7A-3845-B276-F0B0995DA6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0CDF89-6FF0-0E46-A5ED-8EA3CF7B94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E2C3ED-0C54-494B-BCD0-7A7DBF1A5A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0EC44D-D5C3-A94F-B60C-FF195410F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1DE19-8D49-8845-9959-29364BB723B0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442726-C4C7-EB4E-AD77-780705858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9B9028-A798-C94E-8FF7-4723FD8E7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7D6BF-15B7-4741-8CB5-CB002979C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276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4AE646-92DB-154C-8049-59BD37438B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355E692-8857-A24D-84DE-0757E3AC6F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578CC5-FF68-7842-B899-3D4753654A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9FC381-5A2D-A146-B1FC-7E38D3997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1DE19-8D49-8845-9959-29364BB723B0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D82C58-BA36-5646-9BB6-DB0AB2C7B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9DECC6-0387-444D-9EFD-7F9F724C7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7D6BF-15B7-4741-8CB5-CB002979C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195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CBBFE5D-23C4-D948-AF8B-9FFE52D0F2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94CF32-5B30-4247-9159-0E7A7A866D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04B937-A833-EA42-BF55-B16133637A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F1DE19-8D49-8845-9959-29364BB723B0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BA2B53-0716-1145-9A0F-ACC2EDA2DC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3B10E6-AAD6-A647-8A02-941C63FF99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C7D6BF-15B7-4741-8CB5-CB002979C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788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E84311B-D1D2-5C4C-A4D8-289A9A0840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0779" y="0"/>
            <a:ext cx="8443686" cy="291468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9228FF6-7834-F042-A863-EBD1A4007A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8342" y="2914683"/>
            <a:ext cx="9372879" cy="205629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E770567-FF44-9C48-B310-F68B7697BFAD}"/>
              </a:ext>
            </a:extLst>
          </p:cNvPr>
          <p:cNvSpPr txBox="1"/>
          <p:nvPr/>
        </p:nvSpPr>
        <p:spPr>
          <a:xfrm>
            <a:off x="301314" y="10880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D0EEB85-A253-504F-B272-4A5E29DEB7FC}"/>
              </a:ext>
            </a:extLst>
          </p:cNvPr>
          <p:cNvSpPr txBox="1"/>
          <p:nvPr/>
        </p:nvSpPr>
        <p:spPr>
          <a:xfrm>
            <a:off x="301314" y="357349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D35C3A9-AA35-A645-9D48-CD0157E8E01D}"/>
              </a:ext>
            </a:extLst>
          </p:cNvPr>
          <p:cNvSpPr txBox="1"/>
          <p:nvPr/>
        </p:nvSpPr>
        <p:spPr>
          <a:xfrm>
            <a:off x="301314" y="573562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EC3F4F95-396A-B543-95C2-EA015D419B2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031"/>
          <a:stretch/>
        </p:blipFill>
        <p:spPr>
          <a:xfrm>
            <a:off x="301314" y="5128505"/>
            <a:ext cx="5834880" cy="173279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3AAD80E2-BBE7-6B41-9853-93484542B3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79378" y="5128505"/>
            <a:ext cx="5668596" cy="168916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45A80A6-4D20-5A4C-B33D-44034A92B76C}"/>
              </a:ext>
            </a:extLst>
          </p:cNvPr>
          <p:cNvSpPr txBox="1"/>
          <p:nvPr/>
        </p:nvSpPr>
        <p:spPr>
          <a:xfrm>
            <a:off x="5615148" y="5269398"/>
            <a:ext cx="3080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X:Y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D3AB03A-F84C-4141-A8C0-4351A70B5184}"/>
              </a:ext>
            </a:extLst>
          </p:cNvPr>
          <p:cNvSpPr txBox="1"/>
          <p:nvPr/>
        </p:nvSpPr>
        <p:spPr>
          <a:xfrm>
            <a:off x="8578481" y="5334731"/>
            <a:ext cx="3658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Ratio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X:Y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F9A8488-D259-3749-89AB-B19B858569D5}"/>
              </a:ext>
            </a:extLst>
          </p:cNvPr>
          <p:cNvSpPr txBox="1"/>
          <p:nvPr/>
        </p:nvSpPr>
        <p:spPr>
          <a:xfrm>
            <a:off x="11524880" y="5370830"/>
            <a:ext cx="3658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Ratio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X:Y</a:t>
            </a:r>
          </a:p>
        </p:txBody>
      </p:sp>
    </p:spTree>
    <p:extLst>
      <p:ext uri="{BB962C8B-B14F-4D97-AF65-F5344CB8AC3E}">
        <p14:creationId xmlns:p14="http://schemas.microsoft.com/office/powerpoint/2010/main" val="27509343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BF2C926-747C-B74A-9A8B-FB0514BDF7A9}"/>
              </a:ext>
            </a:extLst>
          </p:cNvPr>
          <p:cNvSpPr txBox="1"/>
          <p:nvPr/>
        </p:nvSpPr>
        <p:spPr>
          <a:xfrm>
            <a:off x="148281" y="160638"/>
            <a:ext cx="2343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2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0EAB9FA-1728-CA4E-A1AF-E66C575B4C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74682" y="1255477"/>
            <a:ext cx="1437328" cy="112150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0E53B2A-2427-E149-83ED-2E0B98C3E84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293"/>
          <a:stretch/>
        </p:blipFill>
        <p:spPr>
          <a:xfrm>
            <a:off x="5000585" y="3090711"/>
            <a:ext cx="1656459" cy="138753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4A79637-1FF4-7E4D-9860-1CB6231EEBB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605"/>
          <a:stretch/>
        </p:blipFill>
        <p:spPr>
          <a:xfrm>
            <a:off x="3346453" y="3076514"/>
            <a:ext cx="1656459" cy="141593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CD062C8-1EB2-D046-BB67-483AB16FA2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14594" y="3031819"/>
            <a:ext cx="1893154" cy="150532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707907A-AE27-494D-802C-E43C0672990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82327" y="3085583"/>
            <a:ext cx="1750278" cy="139779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C2848A1-3DAF-B349-9215-80908DF93382}"/>
              </a:ext>
            </a:extLst>
          </p:cNvPr>
          <p:cNvSpPr txBox="1"/>
          <p:nvPr/>
        </p:nvSpPr>
        <p:spPr>
          <a:xfrm>
            <a:off x="3856966" y="121078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AD3827C-50A3-D540-8414-E106D432628D}"/>
              </a:ext>
            </a:extLst>
          </p:cNvPr>
          <p:cNvSpPr txBox="1"/>
          <p:nvPr/>
        </p:nvSpPr>
        <p:spPr>
          <a:xfrm>
            <a:off x="1196878" y="290091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830301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7BA69F1-0860-5542-B1BA-3C7744117F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1144729"/>
              </p:ext>
            </p:extLst>
          </p:nvPr>
        </p:nvGraphicFramePr>
        <p:xfrm>
          <a:off x="-32860" y="165854"/>
          <a:ext cx="12226587" cy="636760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68093">
                  <a:extLst>
                    <a:ext uri="{9D8B030D-6E8A-4147-A177-3AD203B41FA5}">
                      <a16:colId xmlns:a16="http://schemas.microsoft.com/office/drawing/2014/main" val="2899383021"/>
                    </a:ext>
                  </a:extLst>
                </a:gridCol>
                <a:gridCol w="317923">
                  <a:extLst>
                    <a:ext uri="{9D8B030D-6E8A-4147-A177-3AD203B41FA5}">
                      <a16:colId xmlns:a16="http://schemas.microsoft.com/office/drawing/2014/main" val="842330586"/>
                    </a:ext>
                  </a:extLst>
                </a:gridCol>
                <a:gridCol w="817421">
                  <a:extLst>
                    <a:ext uri="{9D8B030D-6E8A-4147-A177-3AD203B41FA5}">
                      <a16:colId xmlns:a16="http://schemas.microsoft.com/office/drawing/2014/main" val="548952754"/>
                    </a:ext>
                  </a:extLst>
                </a:gridCol>
                <a:gridCol w="34909">
                  <a:extLst>
                    <a:ext uri="{9D8B030D-6E8A-4147-A177-3AD203B41FA5}">
                      <a16:colId xmlns:a16="http://schemas.microsoft.com/office/drawing/2014/main" val="3554060812"/>
                    </a:ext>
                  </a:extLst>
                </a:gridCol>
                <a:gridCol w="394250">
                  <a:extLst>
                    <a:ext uri="{9D8B030D-6E8A-4147-A177-3AD203B41FA5}">
                      <a16:colId xmlns:a16="http://schemas.microsoft.com/office/drawing/2014/main" val="314850353"/>
                    </a:ext>
                  </a:extLst>
                </a:gridCol>
                <a:gridCol w="916940">
                  <a:extLst>
                    <a:ext uri="{9D8B030D-6E8A-4147-A177-3AD203B41FA5}">
                      <a16:colId xmlns:a16="http://schemas.microsoft.com/office/drawing/2014/main" val="441665494"/>
                    </a:ext>
                  </a:extLst>
                </a:gridCol>
                <a:gridCol w="34909">
                  <a:extLst>
                    <a:ext uri="{9D8B030D-6E8A-4147-A177-3AD203B41FA5}">
                      <a16:colId xmlns:a16="http://schemas.microsoft.com/office/drawing/2014/main" val="1387852348"/>
                    </a:ext>
                  </a:extLst>
                </a:gridCol>
                <a:gridCol w="334623">
                  <a:extLst>
                    <a:ext uri="{9D8B030D-6E8A-4147-A177-3AD203B41FA5}">
                      <a16:colId xmlns:a16="http://schemas.microsoft.com/office/drawing/2014/main" val="1687380683"/>
                    </a:ext>
                  </a:extLst>
                </a:gridCol>
                <a:gridCol w="754284">
                  <a:extLst>
                    <a:ext uri="{9D8B030D-6E8A-4147-A177-3AD203B41FA5}">
                      <a16:colId xmlns:a16="http://schemas.microsoft.com/office/drawing/2014/main" val="1559958179"/>
                    </a:ext>
                  </a:extLst>
                </a:gridCol>
                <a:gridCol w="150968">
                  <a:extLst>
                    <a:ext uri="{9D8B030D-6E8A-4147-A177-3AD203B41FA5}">
                      <a16:colId xmlns:a16="http://schemas.microsoft.com/office/drawing/2014/main" val="3612638332"/>
                    </a:ext>
                  </a:extLst>
                </a:gridCol>
                <a:gridCol w="466342">
                  <a:extLst>
                    <a:ext uri="{9D8B030D-6E8A-4147-A177-3AD203B41FA5}">
                      <a16:colId xmlns:a16="http://schemas.microsoft.com/office/drawing/2014/main" val="1731345952"/>
                    </a:ext>
                  </a:extLst>
                </a:gridCol>
                <a:gridCol w="768093">
                  <a:extLst>
                    <a:ext uri="{9D8B030D-6E8A-4147-A177-3AD203B41FA5}">
                      <a16:colId xmlns:a16="http://schemas.microsoft.com/office/drawing/2014/main" val="1025441445"/>
                    </a:ext>
                  </a:extLst>
                </a:gridCol>
                <a:gridCol w="58815">
                  <a:extLst>
                    <a:ext uri="{9D8B030D-6E8A-4147-A177-3AD203B41FA5}">
                      <a16:colId xmlns:a16="http://schemas.microsoft.com/office/drawing/2014/main" val="2888921932"/>
                    </a:ext>
                  </a:extLst>
                </a:gridCol>
                <a:gridCol w="504004">
                  <a:extLst>
                    <a:ext uri="{9D8B030D-6E8A-4147-A177-3AD203B41FA5}">
                      <a16:colId xmlns:a16="http://schemas.microsoft.com/office/drawing/2014/main" val="649220551"/>
                    </a:ext>
                  </a:extLst>
                </a:gridCol>
                <a:gridCol w="744768">
                  <a:extLst>
                    <a:ext uri="{9D8B030D-6E8A-4147-A177-3AD203B41FA5}">
                      <a16:colId xmlns:a16="http://schemas.microsoft.com/office/drawing/2014/main" val="3612693225"/>
                    </a:ext>
                  </a:extLst>
                </a:gridCol>
                <a:gridCol w="61039">
                  <a:extLst>
                    <a:ext uri="{9D8B030D-6E8A-4147-A177-3AD203B41FA5}">
                      <a16:colId xmlns:a16="http://schemas.microsoft.com/office/drawing/2014/main" val="1745660036"/>
                    </a:ext>
                  </a:extLst>
                </a:gridCol>
                <a:gridCol w="494425">
                  <a:extLst>
                    <a:ext uri="{9D8B030D-6E8A-4147-A177-3AD203B41FA5}">
                      <a16:colId xmlns:a16="http://schemas.microsoft.com/office/drawing/2014/main" val="3745144489"/>
                    </a:ext>
                  </a:extLst>
                </a:gridCol>
                <a:gridCol w="678973">
                  <a:extLst>
                    <a:ext uri="{9D8B030D-6E8A-4147-A177-3AD203B41FA5}">
                      <a16:colId xmlns:a16="http://schemas.microsoft.com/office/drawing/2014/main" val="3425634278"/>
                    </a:ext>
                  </a:extLst>
                </a:gridCol>
                <a:gridCol w="166624">
                  <a:extLst>
                    <a:ext uri="{9D8B030D-6E8A-4147-A177-3AD203B41FA5}">
                      <a16:colId xmlns:a16="http://schemas.microsoft.com/office/drawing/2014/main" val="1048374358"/>
                    </a:ext>
                  </a:extLst>
                </a:gridCol>
                <a:gridCol w="423332">
                  <a:extLst>
                    <a:ext uri="{9D8B030D-6E8A-4147-A177-3AD203B41FA5}">
                      <a16:colId xmlns:a16="http://schemas.microsoft.com/office/drawing/2014/main" val="2995005717"/>
                    </a:ext>
                  </a:extLst>
                </a:gridCol>
                <a:gridCol w="745065">
                  <a:extLst>
                    <a:ext uri="{9D8B030D-6E8A-4147-A177-3AD203B41FA5}">
                      <a16:colId xmlns:a16="http://schemas.microsoft.com/office/drawing/2014/main" val="1580244280"/>
                    </a:ext>
                  </a:extLst>
                </a:gridCol>
                <a:gridCol w="100583">
                  <a:extLst>
                    <a:ext uri="{9D8B030D-6E8A-4147-A177-3AD203B41FA5}">
                      <a16:colId xmlns:a16="http://schemas.microsoft.com/office/drawing/2014/main" val="1826149090"/>
                    </a:ext>
                  </a:extLst>
                </a:gridCol>
                <a:gridCol w="390481">
                  <a:extLst>
                    <a:ext uri="{9D8B030D-6E8A-4147-A177-3AD203B41FA5}">
                      <a16:colId xmlns:a16="http://schemas.microsoft.com/office/drawing/2014/main" val="1855456430"/>
                    </a:ext>
                  </a:extLst>
                </a:gridCol>
                <a:gridCol w="929953">
                  <a:extLst>
                    <a:ext uri="{9D8B030D-6E8A-4147-A177-3AD203B41FA5}">
                      <a16:colId xmlns:a16="http://schemas.microsoft.com/office/drawing/2014/main" val="1551357943"/>
                    </a:ext>
                  </a:extLst>
                </a:gridCol>
                <a:gridCol w="49427">
                  <a:extLst>
                    <a:ext uri="{9D8B030D-6E8A-4147-A177-3AD203B41FA5}">
                      <a16:colId xmlns:a16="http://schemas.microsoft.com/office/drawing/2014/main" val="3033009342"/>
                    </a:ext>
                  </a:extLst>
                </a:gridCol>
                <a:gridCol w="431500">
                  <a:extLst>
                    <a:ext uri="{9D8B030D-6E8A-4147-A177-3AD203B41FA5}">
                      <a16:colId xmlns:a16="http://schemas.microsoft.com/office/drawing/2014/main" val="3727482579"/>
                    </a:ext>
                  </a:extLst>
                </a:gridCol>
                <a:gridCol w="688843">
                  <a:extLst>
                    <a:ext uri="{9D8B030D-6E8A-4147-A177-3AD203B41FA5}">
                      <a16:colId xmlns:a16="http://schemas.microsoft.com/office/drawing/2014/main" val="2622653226"/>
                    </a:ext>
                  </a:extLst>
                </a:gridCol>
              </a:tblGrid>
              <a:tr h="24034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X333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X2009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X201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89221583"/>
                  </a:ext>
                </a:extLst>
              </a:tr>
              <a:tr h="19456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462 (37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88-14 (37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90-8 (25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462 (5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88-14 (5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90-8 (3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462 (3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88-14 (3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90-8 (3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60619055"/>
                  </a:ext>
                </a:extLst>
              </a:tr>
              <a:tr h="19456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pa (µM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4333816"/>
                  </a:ext>
                </a:extLst>
              </a:tr>
              <a:tr h="19456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01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04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05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1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1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25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3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870637738"/>
                  </a:ext>
                </a:extLst>
              </a:tr>
              <a:tr h="19456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2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3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30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1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01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7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17789483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22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0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35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5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2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42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784920222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51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27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4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ng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4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01186844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0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42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5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61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33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ng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68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67008895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ng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7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37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ng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2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36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ng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46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68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106077222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1606676248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2 (50µM)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3908 (50µM)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6 KO (50µM)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2 (7µM)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3908 (7µM)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6 KO (7</a:t>
                      </a: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µ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2 (5µM)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3908 (7µM)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6 KO (7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µM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1516542766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pa (µM)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8680282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6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0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077443785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25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2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866654935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5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6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5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36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ng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5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36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ng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663087966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37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ng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65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51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9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345831259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endParaRPr lang="en-US" sz="110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53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3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5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734676297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ng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1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01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013110524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1559666165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32043 (50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>
                      <a:noFill/>
                    </a:lnR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32043 (7µM)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43 (7µM)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2647250391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pa (µM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1518152453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9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ng 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2922095237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3475919057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1364001375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382851957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745033746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T-116 (4µM)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-38 (3µM)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2828905411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pa (µM)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2915565450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4166477010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2777718921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691281041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ng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2678875158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3404199554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CBE9CA7-6ACF-3D43-AB1B-54B15CDAC43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9204811"/>
              </p:ext>
            </p:extLst>
          </p:nvPr>
        </p:nvGraphicFramePr>
        <p:xfrm>
          <a:off x="7524088" y="5232400"/>
          <a:ext cx="4445489" cy="16256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04474">
                  <a:extLst>
                    <a:ext uri="{9D8B030D-6E8A-4147-A177-3AD203B41FA5}">
                      <a16:colId xmlns:a16="http://schemas.microsoft.com/office/drawing/2014/main" val="655779858"/>
                    </a:ext>
                  </a:extLst>
                </a:gridCol>
                <a:gridCol w="438130">
                  <a:extLst>
                    <a:ext uri="{9D8B030D-6E8A-4147-A177-3AD203B41FA5}">
                      <a16:colId xmlns:a16="http://schemas.microsoft.com/office/drawing/2014/main" val="2916135586"/>
                    </a:ext>
                  </a:extLst>
                </a:gridCol>
                <a:gridCol w="724955">
                  <a:extLst>
                    <a:ext uri="{9D8B030D-6E8A-4147-A177-3AD203B41FA5}">
                      <a16:colId xmlns:a16="http://schemas.microsoft.com/office/drawing/2014/main" val="631238910"/>
                    </a:ext>
                  </a:extLst>
                </a:gridCol>
                <a:gridCol w="120650">
                  <a:extLst>
                    <a:ext uri="{9D8B030D-6E8A-4147-A177-3AD203B41FA5}">
                      <a16:colId xmlns:a16="http://schemas.microsoft.com/office/drawing/2014/main" val="1697132519"/>
                    </a:ext>
                  </a:extLst>
                </a:gridCol>
                <a:gridCol w="421204">
                  <a:extLst>
                    <a:ext uri="{9D8B030D-6E8A-4147-A177-3AD203B41FA5}">
                      <a16:colId xmlns:a16="http://schemas.microsoft.com/office/drawing/2014/main" val="935558136"/>
                    </a:ext>
                  </a:extLst>
                </a:gridCol>
                <a:gridCol w="711976">
                  <a:extLst>
                    <a:ext uri="{9D8B030D-6E8A-4147-A177-3AD203B41FA5}">
                      <a16:colId xmlns:a16="http://schemas.microsoft.com/office/drawing/2014/main" val="2568059992"/>
                    </a:ext>
                  </a:extLst>
                </a:gridCol>
                <a:gridCol w="1124100">
                  <a:extLst>
                    <a:ext uri="{9D8B030D-6E8A-4147-A177-3AD203B41FA5}">
                      <a16:colId xmlns:a16="http://schemas.microsoft.com/office/drawing/2014/main" val="1835381943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01 (4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02 (2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296180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pa (µM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3925339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282970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>
                      <a:noFill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6061927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79064728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22259823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416263762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697973594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40FD04D7-642E-A240-92BA-F17999B8E06C}"/>
              </a:ext>
            </a:extLst>
          </p:cNvPr>
          <p:cNvSpPr txBox="1"/>
          <p:nvPr/>
        </p:nvSpPr>
        <p:spPr>
          <a:xfrm>
            <a:off x="-32860" y="0"/>
            <a:ext cx="36626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Table 1. CI values for Figure 1 Napa.</a:t>
            </a:r>
          </a:p>
        </p:txBody>
      </p:sp>
    </p:spTree>
    <p:extLst>
      <p:ext uri="{BB962C8B-B14F-4D97-AF65-F5344CB8AC3E}">
        <p14:creationId xmlns:p14="http://schemas.microsoft.com/office/powerpoint/2010/main" val="2364687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6DA8753-5DC4-F248-9778-67A2300C8E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1772719"/>
              </p:ext>
            </p:extLst>
          </p:nvPr>
        </p:nvGraphicFramePr>
        <p:xfrm>
          <a:off x="0" y="817427"/>
          <a:ext cx="12224860" cy="4949643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68096">
                  <a:extLst>
                    <a:ext uri="{9D8B030D-6E8A-4147-A177-3AD203B41FA5}">
                      <a16:colId xmlns:a16="http://schemas.microsoft.com/office/drawing/2014/main" val="2899383021"/>
                    </a:ext>
                  </a:extLst>
                </a:gridCol>
                <a:gridCol w="317925">
                  <a:extLst>
                    <a:ext uri="{9D8B030D-6E8A-4147-A177-3AD203B41FA5}">
                      <a16:colId xmlns:a16="http://schemas.microsoft.com/office/drawing/2014/main" val="842330586"/>
                    </a:ext>
                  </a:extLst>
                </a:gridCol>
                <a:gridCol w="874493">
                  <a:extLst>
                    <a:ext uri="{9D8B030D-6E8A-4147-A177-3AD203B41FA5}">
                      <a16:colId xmlns:a16="http://schemas.microsoft.com/office/drawing/2014/main" val="548952754"/>
                    </a:ext>
                  </a:extLst>
                </a:gridCol>
                <a:gridCol w="61784">
                  <a:extLst>
                    <a:ext uri="{9D8B030D-6E8A-4147-A177-3AD203B41FA5}">
                      <a16:colId xmlns:a16="http://schemas.microsoft.com/office/drawing/2014/main" val="3554060812"/>
                    </a:ext>
                  </a:extLst>
                </a:gridCol>
                <a:gridCol w="309422">
                  <a:extLst>
                    <a:ext uri="{9D8B030D-6E8A-4147-A177-3AD203B41FA5}">
                      <a16:colId xmlns:a16="http://schemas.microsoft.com/office/drawing/2014/main" val="314850353"/>
                    </a:ext>
                  </a:extLst>
                </a:gridCol>
                <a:gridCol w="916943">
                  <a:extLst>
                    <a:ext uri="{9D8B030D-6E8A-4147-A177-3AD203B41FA5}">
                      <a16:colId xmlns:a16="http://schemas.microsoft.com/office/drawing/2014/main" val="441665494"/>
                    </a:ext>
                  </a:extLst>
                </a:gridCol>
                <a:gridCol w="34024">
                  <a:extLst>
                    <a:ext uri="{9D8B030D-6E8A-4147-A177-3AD203B41FA5}">
                      <a16:colId xmlns:a16="http://schemas.microsoft.com/office/drawing/2014/main" val="1387852348"/>
                    </a:ext>
                  </a:extLst>
                </a:gridCol>
                <a:gridCol w="334624">
                  <a:extLst>
                    <a:ext uri="{9D8B030D-6E8A-4147-A177-3AD203B41FA5}">
                      <a16:colId xmlns:a16="http://schemas.microsoft.com/office/drawing/2014/main" val="1687380683"/>
                    </a:ext>
                  </a:extLst>
                </a:gridCol>
                <a:gridCol w="863981">
                  <a:extLst>
                    <a:ext uri="{9D8B030D-6E8A-4147-A177-3AD203B41FA5}">
                      <a16:colId xmlns:a16="http://schemas.microsoft.com/office/drawing/2014/main" val="1559958179"/>
                    </a:ext>
                  </a:extLst>
                </a:gridCol>
                <a:gridCol w="41275">
                  <a:extLst>
                    <a:ext uri="{9D8B030D-6E8A-4147-A177-3AD203B41FA5}">
                      <a16:colId xmlns:a16="http://schemas.microsoft.com/office/drawing/2014/main" val="3612638332"/>
                    </a:ext>
                  </a:extLst>
                </a:gridCol>
                <a:gridCol w="466344">
                  <a:extLst>
                    <a:ext uri="{9D8B030D-6E8A-4147-A177-3AD203B41FA5}">
                      <a16:colId xmlns:a16="http://schemas.microsoft.com/office/drawing/2014/main" val="1731345952"/>
                    </a:ext>
                  </a:extLst>
                </a:gridCol>
                <a:gridCol w="768096">
                  <a:extLst>
                    <a:ext uri="{9D8B030D-6E8A-4147-A177-3AD203B41FA5}">
                      <a16:colId xmlns:a16="http://schemas.microsoft.com/office/drawing/2014/main" val="1025441445"/>
                    </a:ext>
                  </a:extLst>
                </a:gridCol>
                <a:gridCol w="58815">
                  <a:extLst>
                    <a:ext uri="{9D8B030D-6E8A-4147-A177-3AD203B41FA5}">
                      <a16:colId xmlns:a16="http://schemas.microsoft.com/office/drawing/2014/main" val="2888921932"/>
                    </a:ext>
                  </a:extLst>
                </a:gridCol>
                <a:gridCol w="504006">
                  <a:extLst>
                    <a:ext uri="{9D8B030D-6E8A-4147-A177-3AD203B41FA5}">
                      <a16:colId xmlns:a16="http://schemas.microsoft.com/office/drawing/2014/main" val="649220551"/>
                    </a:ext>
                  </a:extLst>
                </a:gridCol>
                <a:gridCol w="744771">
                  <a:extLst>
                    <a:ext uri="{9D8B030D-6E8A-4147-A177-3AD203B41FA5}">
                      <a16:colId xmlns:a16="http://schemas.microsoft.com/office/drawing/2014/main" val="3612693225"/>
                    </a:ext>
                  </a:extLst>
                </a:gridCol>
                <a:gridCol w="61039">
                  <a:extLst>
                    <a:ext uri="{9D8B030D-6E8A-4147-A177-3AD203B41FA5}">
                      <a16:colId xmlns:a16="http://schemas.microsoft.com/office/drawing/2014/main" val="1745660036"/>
                    </a:ext>
                  </a:extLst>
                </a:gridCol>
                <a:gridCol w="494426">
                  <a:extLst>
                    <a:ext uri="{9D8B030D-6E8A-4147-A177-3AD203B41FA5}">
                      <a16:colId xmlns:a16="http://schemas.microsoft.com/office/drawing/2014/main" val="3745144489"/>
                    </a:ext>
                  </a:extLst>
                </a:gridCol>
                <a:gridCol w="678975">
                  <a:extLst>
                    <a:ext uri="{9D8B030D-6E8A-4147-A177-3AD203B41FA5}">
                      <a16:colId xmlns:a16="http://schemas.microsoft.com/office/drawing/2014/main" val="3425634278"/>
                    </a:ext>
                  </a:extLst>
                </a:gridCol>
                <a:gridCol w="166624">
                  <a:extLst>
                    <a:ext uri="{9D8B030D-6E8A-4147-A177-3AD203B41FA5}">
                      <a16:colId xmlns:a16="http://schemas.microsoft.com/office/drawing/2014/main" val="1048374358"/>
                    </a:ext>
                  </a:extLst>
                </a:gridCol>
                <a:gridCol w="423333">
                  <a:extLst>
                    <a:ext uri="{9D8B030D-6E8A-4147-A177-3AD203B41FA5}">
                      <a16:colId xmlns:a16="http://schemas.microsoft.com/office/drawing/2014/main" val="2995005717"/>
                    </a:ext>
                  </a:extLst>
                </a:gridCol>
                <a:gridCol w="745067">
                  <a:extLst>
                    <a:ext uri="{9D8B030D-6E8A-4147-A177-3AD203B41FA5}">
                      <a16:colId xmlns:a16="http://schemas.microsoft.com/office/drawing/2014/main" val="1580244280"/>
                    </a:ext>
                  </a:extLst>
                </a:gridCol>
                <a:gridCol w="100584">
                  <a:extLst>
                    <a:ext uri="{9D8B030D-6E8A-4147-A177-3AD203B41FA5}">
                      <a16:colId xmlns:a16="http://schemas.microsoft.com/office/drawing/2014/main" val="1826149090"/>
                    </a:ext>
                  </a:extLst>
                </a:gridCol>
                <a:gridCol w="390483">
                  <a:extLst>
                    <a:ext uri="{9D8B030D-6E8A-4147-A177-3AD203B41FA5}">
                      <a16:colId xmlns:a16="http://schemas.microsoft.com/office/drawing/2014/main" val="1855456430"/>
                    </a:ext>
                  </a:extLst>
                </a:gridCol>
                <a:gridCol w="880530">
                  <a:extLst>
                    <a:ext uri="{9D8B030D-6E8A-4147-A177-3AD203B41FA5}">
                      <a16:colId xmlns:a16="http://schemas.microsoft.com/office/drawing/2014/main" val="1551357943"/>
                    </a:ext>
                  </a:extLst>
                </a:gridCol>
                <a:gridCol w="34024">
                  <a:extLst>
                    <a:ext uri="{9D8B030D-6E8A-4147-A177-3AD203B41FA5}">
                      <a16:colId xmlns:a16="http://schemas.microsoft.com/office/drawing/2014/main" val="3033009342"/>
                    </a:ext>
                  </a:extLst>
                </a:gridCol>
                <a:gridCol w="496331">
                  <a:extLst>
                    <a:ext uri="{9D8B030D-6E8A-4147-A177-3AD203B41FA5}">
                      <a16:colId xmlns:a16="http://schemas.microsoft.com/office/drawing/2014/main" val="3727482579"/>
                    </a:ext>
                  </a:extLst>
                </a:gridCol>
                <a:gridCol w="688845">
                  <a:extLst>
                    <a:ext uri="{9D8B030D-6E8A-4147-A177-3AD203B41FA5}">
                      <a16:colId xmlns:a16="http://schemas.microsoft.com/office/drawing/2014/main" val="2622653226"/>
                    </a:ext>
                  </a:extLst>
                </a:gridCol>
              </a:tblGrid>
              <a:tr h="24034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X3330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X2009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X201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89221583"/>
                  </a:ext>
                </a:extLst>
              </a:tr>
              <a:tr h="19456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2 (50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32043 (50µM)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3908 (50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2 (5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32043 (5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3908 (7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2 (5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32043 (5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PC3908 (5µ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60619055"/>
                  </a:ext>
                </a:extLst>
              </a:tr>
              <a:tr h="194566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x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µM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4333816"/>
                  </a:ext>
                </a:extLst>
              </a:tr>
              <a:tr h="19456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25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6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870637738"/>
                  </a:ext>
                </a:extLst>
              </a:tr>
              <a:tr h="19456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5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17789483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5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ng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0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784920222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2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01186844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8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2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67008895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3080776989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6-KO (37µM)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6-KO (5µM)</a:t>
                      </a:r>
                    </a:p>
                  </a:txBody>
                  <a:tcPr marL="4312" marR="4312" marT="43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6-KO (5µM)</a:t>
                      </a:r>
                    </a:p>
                  </a:txBody>
                  <a:tcPr marL="4312" marR="4312" marT="43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1350281278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x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µM)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503097226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25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3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</a:p>
                  </a:txBody>
                  <a:tcPr marL="4312" marR="4312" marT="43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1021588769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5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0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1787346866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5</a:t>
                      </a:r>
                    </a:p>
                  </a:txBody>
                  <a:tcPr marL="4312" marR="4312" marT="4312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</a:t>
                      </a:r>
                    </a:p>
                  </a:txBody>
                  <a:tcPr marL="4312" marR="4312" marT="431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7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1106077222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6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ight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4152903327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3420407517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6676248"/>
                  </a:ext>
                </a:extLst>
              </a:tr>
              <a:tr h="10493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88-14 (37µM)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>
                      <a:noFill/>
                    </a:lnR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88-14 (5µM)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>
                      <a:noFill/>
                    </a:lnR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88-14 (µM)</a:t>
                      </a:r>
                    </a:p>
                  </a:txBody>
                  <a:tcPr marL="4312" marR="4312" marT="431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>
                      <a:noFill/>
                    </a:lnR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1516542766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x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µM)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ergy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18680282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2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9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077443785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1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4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3866654935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0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3663087966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5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6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8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2345831259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 syn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734676297"/>
                  </a:ext>
                </a:extLst>
              </a:tr>
              <a:tr h="183121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d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0</a:t>
                      </a: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</a:t>
                      </a:r>
                    </a:p>
                  </a:txBody>
                  <a:tcPr marL="4312" marR="4312" marT="4312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2013110524"/>
                  </a:ext>
                </a:extLst>
              </a:tr>
              <a:tr h="6549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312" marR="4312" marT="4312" marB="0" anchor="b"/>
                </a:tc>
                <a:extLst>
                  <a:ext uri="{0D108BD9-81ED-4DB2-BD59-A6C34878D82A}">
                    <a16:rowId xmlns:a16="http://schemas.microsoft.com/office/drawing/2014/main" val="1559666165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B59F2E2-E4C2-6E46-8325-25B77A8B1896}"/>
              </a:ext>
            </a:extLst>
          </p:cNvPr>
          <p:cNvGraphicFramePr>
            <a:graphicFrameLocks noGrp="1"/>
          </p:cNvGraphicFramePr>
          <p:nvPr/>
        </p:nvGraphicFramePr>
        <p:xfrm>
          <a:off x="12413430" y="1680702"/>
          <a:ext cx="2216969" cy="20506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16969">
                  <a:extLst>
                    <a:ext uri="{9D8B030D-6E8A-4147-A177-3AD203B41FA5}">
                      <a16:colId xmlns:a16="http://schemas.microsoft.com/office/drawing/2014/main" val="1158566627"/>
                    </a:ext>
                  </a:extLst>
                </a:gridCol>
              </a:tblGrid>
              <a:tr h="25668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I &gt; 1.3 indicates antagonism,</a:t>
                      </a:r>
                      <a:endParaRPr lang="en-US" sz="900" b="0" i="0" u="none" strike="noStrike">
                        <a:solidFill>
                          <a:srgbClr val="11111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2" marR="6012" marT="6012" marB="0" anchor="b"/>
                </a:tc>
                <a:extLst>
                  <a:ext uri="{0D108BD9-81ED-4DB2-BD59-A6C34878D82A}">
                    <a16:rowId xmlns:a16="http://schemas.microsoft.com/office/drawing/2014/main" val="3687660711"/>
                  </a:ext>
                </a:extLst>
              </a:tr>
              <a:tr h="3201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I = 1.1 to 1.3 moderate antagonism,</a:t>
                      </a:r>
                      <a:endParaRPr lang="en-US" sz="900" b="0" i="0" u="none" strike="noStrike">
                        <a:solidFill>
                          <a:srgbClr val="11111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2" marR="6012" marT="6012" marB="0" anchor="b"/>
                </a:tc>
                <a:extLst>
                  <a:ext uri="{0D108BD9-81ED-4DB2-BD59-A6C34878D82A}">
                    <a16:rowId xmlns:a16="http://schemas.microsoft.com/office/drawing/2014/main" val="2983873539"/>
                  </a:ext>
                </a:extLst>
              </a:tr>
              <a:tr h="25668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I = 0.9 to 1.1 additive effect,</a:t>
                      </a:r>
                      <a:endParaRPr lang="en-US" sz="900" b="0" i="0" u="none" strike="noStrike">
                        <a:solidFill>
                          <a:srgbClr val="11111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2" marR="6012" marT="6012" marB="0" anchor="b"/>
                </a:tc>
                <a:extLst>
                  <a:ext uri="{0D108BD9-81ED-4DB2-BD59-A6C34878D82A}">
                    <a16:rowId xmlns:a16="http://schemas.microsoft.com/office/drawing/2014/main" val="2091546189"/>
                  </a:ext>
                </a:extLst>
              </a:tr>
              <a:tr h="3201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I = 0.8 to 0.9 slight synergism,</a:t>
                      </a:r>
                      <a:endParaRPr lang="en-US" sz="900" b="0" i="0" u="none" strike="noStrike">
                        <a:solidFill>
                          <a:srgbClr val="11111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2" marR="6012" marT="6012" marB="0" anchor="b"/>
                </a:tc>
                <a:extLst>
                  <a:ext uri="{0D108BD9-81ED-4DB2-BD59-A6C34878D82A}">
                    <a16:rowId xmlns:a16="http://schemas.microsoft.com/office/drawing/2014/main" val="523314753"/>
                  </a:ext>
                </a:extLst>
              </a:tr>
              <a:tr h="3201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I = 0.6 to 0.8 moderate synergism,</a:t>
                      </a:r>
                      <a:endParaRPr lang="en-US" sz="900" b="0" i="0" u="none" strike="noStrike">
                        <a:solidFill>
                          <a:srgbClr val="11111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2" marR="6012" marT="6012" marB="0" anchor="b"/>
                </a:tc>
                <a:extLst>
                  <a:ext uri="{0D108BD9-81ED-4DB2-BD59-A6C34878D82A}">
                    <a16:rowId xmlns:a16="http://schemas.microsoft.com/office/drawing/2014/main" val="2558930330"/>
                  </a:ext>
                </a:extLst>
              </a:tr>
              <a:tr h="25668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I = 0.4 to 0.6 synergism,</a:t>
                      </a:r>
                      <a:endParaRPr lang="en-US" sz="900" b="0" i="0" u="none" strike="noStrike">
                        <a:solidFill>
                          <a:srgbClr val="11111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2" marR="6012" marT="6012" marB="0" anchor="b"/>
                </a:tc>
                <a:extLst>
                  <a:ext uri="{0D108BD9-81ED-4DB2-BD59-A6C34878D82A}">
                    <a16:rowId xmlns:a16="http://schemas.microsoft.com/office/drawing/2014/main" val="1680343780"/>
                  </a:ext>
                </a:extLst>
              </a:tr>
              <a:tr h="3201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CI = 0.2 to 0.4 strong synergism.</a:t>
                      </a:r>
                      <a:endParaRPr lang="en-US" sz="900" b="0" i="0" u="none" strike="noStrike" dirty="0">
                        <a:solidFill>
                          <a:srgbClr val="11111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12" marR="6012" marT="6012" marB="0" anchor="b"/>
                </a:tc>
                <a:extLst>
                  <a:ext uri="{0D108BD9-81ED-4DB2-BD59-A6C34878D82A}">
                    <a16:rowId xmlns:a16="http://schemas.microsoft.com/office/drawing/2014/main" val="3954732393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2DA5FDAF-E14D-2F46-A6C5-0BDF617C005C}"/>
              </a:ext>
            </a:extLst>
          </p:cNvPr>
          <p:cNvSpPr/>
          <p:nvPr/>
        </p:nvSpPr>
        <p:spPr>
          <a:xfrm>
            <a:off x="119644" y="143325"/>
            <a:ext cx="413055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Table 2. CI values for Figure 1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Rux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656367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8</TotalTime>
  <Words>890</Words>
  <Application>Microsoft Macintosh PowerPoint</Application>
  <PresentationFormat>Widescreen</PresentationFormat>
  <Paragraphs>58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shel, Melissa L</dc:creator>
  <cp:lastModifiedBy>Fishel, Melissa L</cp:lastModifiedBy>
  <cp:revision>37</cp:revision>
  <dcterms:created xsi:type="dcterms:W3CDTF">2020-08-04T16:39:58Z</dcterms:created>
  <dcterms:modified xsi:type="dcterms:W3CDTF">2020-09-24T13:13:01Z</dcterms:modified>
</cp:coreProperties>
</file>